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F45AA"/>
    <a:srgbClr val="FF0000"/>
    <a:srgbClr val="0070C0"/>
    <a:srgbClr val="00B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29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587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360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667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068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337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714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441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863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152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919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681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96CE8-2B5E-4FF1-AD59-91890236E63B}" type="datetimeFigureOut">
              <a:rPr lang="en-US" smtClean="0"/>
              <a:t>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15771-FB25-4D58-9C97-F01053B9B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234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Picture 114"/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60757"/>
          <a:stretch/>
        </p:blipFill>
        <p:spPr>
          <a:xfrm>
            <a:off x="3905249" y="351265"/>
            <a:ext cx="2980703" cy="5690397"/>
          </a:xfrm>
          <a:prstGeom prst="rect">
            <a:avLst/>
          </a:prstGeom>
        </p:spPr>
      </p:pic>
      <p:pic>
        <p:nvPicPr>
          <p:cNvPr id="81" name="Picture 80"/>
          <p:cNvPicPr>
            <a:picLocks noChangeAspect="1"/>
          </p:cNvPicPr>
          <p:nvPr/>
        </p:nvPicPr>
        <p:blipFill rotWithShape="1">
          <a:blip r:embed="rId2"/>
          <a:srcRect r="84697"/>
          <a:stretch/>
        </p:blipFill>
        <p:spPr>
          <a:xfrm>
            <a:off x="2561947" y="349286"/>
            <a:ext cx="1162328" cy="569039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399388" y="43134"/>
            <a:ext cx="1393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paradoxus</a:t>
            </a:r>
            <a:endParaRPr lang="en-US" sz="1600" i="1" dirty="0">
              <a:solidFill>
                <a:schemeClr val="accent2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236236" y="32219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238385" y="69113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209958" y="1065204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209052" y="142122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.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238557" y="245309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240706" y="286204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212279" y="328690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205023" y="3708974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.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240729" y="478139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242878" y="499111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212070" y="5200358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207195" y="540283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.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209891" y="5617801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.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1649132" y="5246828"/>
            <a:ext cx="1127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g2 Adaptation tim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1636248" y="3069112"/>
            <a:ext cx="11512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g2 maximum OD</a:t>
            </a:r>
            <a:r>
              <a:rPr lang="en-US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1435854" y="926495"/>
            <a:ext cx="1553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g2 maximum growth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ate (µ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242864" y="457486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2205023" y="4245678"/>
            <a:ext cx="4645485" cy="3140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2202271" y="2097106"/>
            <a:ext cx="4645485" cy="3140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2668421" y="33504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877082" y="33504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096157" y="33028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320947" y="32466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8841890">
            <a:off x="2597172" y="596965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8841890">
            <a:off x="2249203" y="6223731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merica (B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8841890">
            <a:off x="2475139" y="6231483"/>
            <a:ext cx="9946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merica (C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8841890">
            <a:off x="2677697" y="6241070"/>
            <a:ext cx="1063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merica (C*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211803" y="5821957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2.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114997" y="38521"/>
            <a:ext cx="7392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100724" y="2168915"/>
            <a:ext cx="7392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114997" y="4301664"/>
            <a:ext cx="7392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148532" y="43134"/>
            <a:ext cx="11208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uvarum</a:t>
            </a:r>
            <a:endParaRPr lang="en-US" sz="1600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600835" y="43134"/>
            <a:ext cx="14382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eubayanus</a:t>
            </a:r>
            <a:endParaRPr lang="en-US" sz="1600" i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82"/>
          <p:cNvSpPr/>
          <p:nvPr/>
        </p:nvSpPr>
        <p:spPr>
          <a:xfrm flipV="1">
            <a:off x="3759214" y="317129"/>
            <a:ext cx="391111" cy="57225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 flipV="1">
            <a:off x="5381775" y="356631"/>
            <a:ext cx="391111" cy="57225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xtBox 84"/>
          <p:cNvSpPr txBox="1"/>
          <p:nvPr/>
        </p:nvSpPr>
        <p:spPr>
          <a:xfrm>
            <a:off x="5907707" y="3801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6212501" y="37533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6516499" y="3801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18841890">
            <a:off x="3625590" y="6188670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dmixtur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8841890">
            <a:off x="3932882" y="6166400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OL-EU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8841890">
            <a:off x="4174637" y="6133888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OL-N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18841890">
            <a:off x="4551069" y="6069387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-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 rot="18841890">
            <a:off x="4744084" y="6084407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-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 rot="18841890">
            <a:off x="5317644" y="6193906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dmixtur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 rot="18841890">
            <a:off x="5541544" y="6214549"/>
            <a:ext cx="10113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agonia 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 rot="18841890">
            <a:off x="5883846" y="6237489"/>
            <a:ext cx="10198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agonia 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230254" y="25124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4412631" y="252152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547383" y="2510709"/>
            <a:ext cx="3401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770614" y="251633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4954214" y="25125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Arrow Connector 104"/>
          <p:cNvCxnSpPr/>
          <p:nvPr/>
        </p:nvCxnSpPr>
        <p:spPr>
          <a:xfrm>
            <a:off x="4484370" y="1247456"/>
            <a:ext cx="135255" cy="0"/>
          </a:xfrm>
          <a:prstGeom prst="straightConnector1">
            <a:avLst/>
          </a:prstGeom>
          <a:ln w="38100">
            <a:solidFill>
              <a:srgbClr val="FF0000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>
            <a:off x="6546648" y="1358204"/>
            <a:ext cx="186035" cy="0"/>
          </a:xfrm>
          <a:prstGeom prst="straightConnector1">
            <a:avLst/>
          </a:prstGeom>
          <a:ln w="38100">
            <a:solidFill>
              <a:srgbClr val="7F45AA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/>
          <p:cNvCxnSpPr/>
          <p:nvPr/>
        </p:nvCxnSpPr>
        <p:spPr>
          <a:xfrm>
            <a:off x="4486858" y="3158364"/>
            <a:ext cx="135255" cy="0"/>
          </a:xfrm>
          <a:prstGeom prst="straightConnector1">
            <a:avLst/>
          </a:prstGeom>
          <a:ln w="38100">
            <a:solidFill>
              <a:srgbClr val="FF0000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>
            <a:off x="6545326" y="3380237"/>
            <a:ext cx="186035" cy="0"/>
          </a:xfrm>
          <a:prstGeom prst="straightConnector1">
            <a:avLst/>
          </a:prstGeom>
          <a:ln w="38100">
            <a:solidFill>
              <a:srgbClr val="7F45AA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/>
          <p:cNvCxnSpPr/>
          <p:nvPr/>
        </p:nvCxnSpPr>
        <p:spPr>
          <a:xfrm>
            <a:off x="4486384" y="5458981"/>
            <a:ext cx="135255" cy="0"/>
          </a:xfrm>
          <a:prstGeom prst="straightConnector1">
            <a:avLst/>
          </a:prstGeom>
          <a:ln w="38100">
            <a:solidFill>
              <a:srgbClr val="FF0000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>
            <a:off x="6544979" y="5141866"/>
            <a:ext cx="186035" cy="0"/>
          </a:xfrm>
          <a:prstGeom prst="straightConnector1">
            <a:avLst/>
          </a:prstGeom>
          <a:ln w="38100">
            <a:solidFill>
              <a:srgbClr val="7F45AA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418817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8</TotalTime>
  <Words>83</Words>
  <Application>Microsoft Office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VE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24</cp:revision>
  <cp:lastPrinted>2016-08-29T23:04:57Z</cp:lastPrinted>
  <dcterms:created xsi:type="dcterms:W3CDTF">2015-12-08T22:49:46Z</dcterms:created>
  <dcterms:modified xsi:type="dcterms:W3CDTF">2017-01-30T16:21:37Z</dcterms:modified>
</cp:coreProperties>
</file>